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6" r:id="rId2"/>
    <p:sldId id="285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94"/>
  </p:normalViewPr>
  <p:slideViewPr>
    <p:cSldViewPr snapToGrid="0" snapToObjects="1">
      <p:cViewPr varScale="1">
        <p:scale>
          <a:sx n="109" d="100"/>
          <a:sy n="109" d="100"/>
        </p:scale>
        <p:origin x="100" y="29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8472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4069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550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349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0963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01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1790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9199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335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766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6464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298A9-11DE-1C45-9EA5-2599C8F6B2EC}" type="datetimeFigureOut">
              <a:rPr kumimoji="1" lang="ja-JP" altLang="en-US" smtClean="0"/>
              <a:t>2022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C071A-970B-9340-98AC-E220A4ADD5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2311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0" y="0"/>
            <a:ext cx="8938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Legend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: Images from Figure 5A, the original image of the full raw unedited gel 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EE575B7-8FD8-C646-ACD9-4D5844E431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535" y="3625575"/>
            <a:ext cx="3517900" cy="20955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4F822BD1-20C0-F44F-8942-41B200FDF5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6303" y="3607904"/>
            <a:ext cx="3517900" cy="2222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9136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0" y="0"/>
            <a:ext cx="9143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Legend: Images from Figure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5A, gel image with information </a:t>
            </a:r>
            <a:endParaRPr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 rot="18021029">
            <a:off x="1813515" y="2509813"/>
            <a:ext cx="2039792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②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</a:t>
            </a:r>
          </a:p>
        </p:txBody>
      </p:sp>
      <p:sp>
        <p:nvSpPr>
          <p:cNvPr id="12" name="正方形/長方形 11"/>
          <p:cNvSpPr/>
          <p:nvPr/>
        </p:nvSpPr>
        <p:spPr>
          <a:xfrm rot="18021029">
            <a:off x="626986" y="2741567"/>
            <a:ext cx="1656719" cy="404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Dyn1 sup</a:t>
            </a:r>
          </a:p>
        </p:txBody>
      </p:sp>
      <p:sp>
        <p:nvSpPr>
          <p:cNvPr id="13" name="正方形/長方形 12"/>
          <p:cNvSpPr/>
          <p:nvPr/>
        </p:nvSpPr>
        <p:spPr>
          <a:xfrm rot="18021029">
            <a:off x="967483" y="2799116"/>
            <a:ext cx="1523336" cy="404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Dyn1 ppt</a:t>
            </a:r>
          </a:p>
        </p:txBody>
      </p:sp>
      <p:sp>
        <p:nvSpPr>
          <p:cNvPr id="14" name="正方形/長方形 13"/>
          <p:cNvSpPr/>
          <p:nvPr/>
        </p:nvSpPr>
        <p:spPr>
          <a:xfrm rot="18021029">
            <a:off x="1127556" y="2393173"/>
            <a:ext cx="2363834" cy="404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 sup</a:t>
            </a:r>
          </a:p>
        </p:txBody>
      </p:sp>
      <p:sp>
        <p:nvSpPr>
          <p:cNvPr id="15" name="正方形/長方形 14"/>
          <p:cNvSpPr/>
          <p:nvPr/>
        </p:nvSpPr>
        <p:spPr>
          <a:xfrm rot="18021029">
            <a:off x="1417926" y="2343602"/>
            <a:ext cx="2459652" cy="4044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 ppt</a:t>
            </a:r>
          </a:p>
        </p:txBody>
      </p:sp>
      <p:sp>
        <p:nvSpPr>
          <p:cNvPr id="16" name="正方形/長方形 15"/>
          <p:cNvSpPr/>
          <p:nvPr/>
        </p:nvSpPr>
        <p:spPr>
          <a:xfrm rot="18021029">
            <a:off x="2134461" y="2492915"/>
            <a:ext cx="2078303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②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pt</a:t>
            </a:r>
          </a:p>
        </p:txBody>
      </p:sp>
      <p:sp>
        <p:nvSpPr>
          <p:cNvPr id="18" name="正方形/長方形 17"/>
          <p:cNvSpPr/>
          <p:nvPr/>
        </p:nvSpPr>
        <p:spPr>
          <a:xfrm rot="18021029">
            <a:off x="2471390" y="2511576"/>
            <a:ext cx="2012022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③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sup</a:t>
            </a:r>
          </a:p>
        </p:txBody>
      </p:sp>
      <p:sp>
        <p:nvSpPr>
          <p:cNvPr id="19" name="正方形/長方形 18"/>
          <p:cNvSpPr/>
          <p:nvPr/>
        </p:nvSpPr>
        <p:spPr>
          <a:xfrm rot="18021029">
            <a:off x="2808719" y="2505940"/>
            <a:ext cx="2024430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③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pt</a:t>
            </a:r>
          </a:p>
        </p:txBody>
      </p:sp>
      <p:sp>
        <p:nvSpPr>
          <p:cNvPr id="21" name="正方形/長方形 20"/>
          <p:cNvSpPr/>
          <p:nvPr/>
        </p:nvSpPr>
        <p:spPr>
          <a:xfrm rot="18021029">
            <a:off x="4179432" y="1965152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⑬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</a:t>
            </a:r>
          </a:p>
        </p:txBody>
      </p:sp>
      <p:sp>
        <p:nvSpPr>
          <p:cNvPr id="22" name="正方形/長方形 21"/>
          <p:cNvSpPr/>
          <p:nvPr/>
        </p:nvSpPr>
        <p:spPr>
          <a:xfrm rot="18021029">
            <a:off x="4480087" y="1954932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⑬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pt</a:t>
            </a:r>
          </a:p>
        </p:txBody>
      </p:sp>
      <p:sp>
        <p:nvSpPr>
          <p:cNvPr id="23" name="正方形/長方形 22"/>
          <p:cNvSpPr/>
          <p:nvPr/>
        </p:nvSpPr>
        <p:spPr>
          <a:xfrm rot="18021029">
            <a:off x="4787614" y="1944992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⑦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sup</a:t>
            </a:r>
          </a:p>
        </p:txBody>
      </p:sp>
      <p:sp>
        <p:nvSpPr>
          <p:cNvPr id="24" name="正方形/長方形 23"/>
          <p:cNvSpPr/>
          <p:nvPr/>
        </p:nvSpPr>
        <p:spPr>
          <a:xfrm rot="18021029">
            <a:off x="5111208" y="1949431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⑦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pt</a:t>
            </a:r>
          </a:p>
        </p:txBody>
      </p:sp>
      <p:sp>
        <p:nvSpPr>
          <p:cNvPr id="25" name="正方形/長方形 24"/>
          <p:cNvSpPr/>
          <p:nvPr/>
        </p:nvSpPr>
        <p:spPr>
          <a:xfrm rot="18021029">
            <a:off x="5424259" y="1929552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⑤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</a:t>
            </a:r>
          </a:p>
        </p:txBody>
      </p:sp>
      <p:sp>
        <p:nvSpPr>
          <p:cNvPr id="26" name="正方形/長方形 25"/>
          <p:cNvSpPr/>
          <p:nvPr/>
        </p:nvSpPr>
        <p:spPr>
          <a:xfrm rot="18021029">
            <a:off x="5737315" y="1925396"/>
            <a:ext cx="3308521" cy="4027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Dyn1+MT+peptide</a:t>
            </a:r>
            <a:r>
              <a:rPr lang="ja-JP" altLang="en-US" sz="1200" b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⑤ </a:t>
            </a:r>
            <a:r>
              <a:rPr lang="en-US" altLang="ja-JP" sz="1200" b="1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pt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BEE575B7-8FD8-C646-ACD9-4D5844E431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535" y="3625575"/>
            <a:ext cx="3517900" cy="20955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4F822BD1-20C0-F44F-8942-41B200FDF5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6303" y="3607904"/>
            <a:ext cx="3517900" cy="2222500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CB37BED-86CE-524C-AD28-AAD526724469}"/>
              </a:ext>
            </a:extLst>
          </p:cNvPr>
          <p:cNvSpPr txBox="1"/>
          <p:nvPr/>
        </p:nvSpPr>
        <p:spPr>
          <a:xfrm>
            <a:off x="258105" y="805982"/>
            <a:ext cx="392929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yn1 (1</a:t>
            </a:r>
            <a:r>
              <a:rPr kumimoji="1" lang="en-US" altLang="ja-JP" b="1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T (microtubule) (1.5</a:t>
            </a:r>
            <a:r>
              <a:rPr lang="en-US" altLang="ja-JP" b="1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</a:p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ptide (1mM)</a:t>
            </a:r>
            <a:endParaRPr kumimoji="1" lang="ja-JP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B2BD15AF-00F4-D74E-8FD2-9BAAA378B954}"/>
              </a:ext>
            </a:extLst>
          </p:cNvPr>
          <p:cNvSpPr/>
          <p:nvPr/>
        </p:nvSpPr>
        <p:spPr>
          <a:xfrm>
            <a:off x="742774" y="3625575"/>
            <a:ext cx="922806" cy="2133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FFAC54C0-4650-0542-9BE8-7437B7036C3A}"/>
              </a:ext>
            </a:extLst>
          </p:cNvPr>
          <p:cNvSpPr/>
          <p:nvPr/>
        </p:nvSpPr>
        <p:spPr>
          <a:xfrm>
            <a:off x="1700040" y="3625575"/>
            <a:ext cx="601644" cy="2133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E7786363-0040-DD4F-ACFF-3036B27CED4F}"/>
              </a:ext>
            </a:extLst>
          </p:cNvPr>
          <p:cNvSpPr/>
          <p:nvPr/>
        </p:nvSpPr>
        <p:spPr>
          <a:xfrm>
            <a:off x="6232284" y="3625575"/>
            <a:ext cx="601644" cy="2133600"/>
          </a:xfrm>
          <a:prstGeom prst="rect">
            <a:avLst/>
          </a:prstGeom>
          <a:noFill/>
          <a:ln w="1905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2CCC51F-99C2-1D47-9FFD-F2ACE3664CE1}"/>
              </a:ext>
            </a:extLst>
          </p:cNvPr>
          <p:cNvSpPr txBox="1"/>
          <p:nvPr/>
        </p:nvSpPr>
        <p:spPr>
          <a:xfrm>
            <a:off x="6068869" y="5941452"/>
            <a:ext cx="14017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or Fig 5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sz="16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AD890EE-471F-484A-83F3-7A083B8DA78B}"/>
              </a:ext>
            </a:extLst>
          </p:cNvPr>
          <p:cNvSpPr txBox="1"/>
          <p:nvPr/>
        </p:nvSpPr>
        <p:spPr>
          <a:xfrm>
            <a:off x="1069486" y="5941452"/>
            <a:ext cx="140170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or Fig 5A</a:t>
            </a:r>
            <a:endParaRPr lang="ja-JP" altLang="en-US" sz="1600" b="1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sz="1600"/>
          </a:p>
        </p:txBody>
      </p: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AC562EFD-B528-9D44-A399-FEF837CA47D5}"/>
              </a:ext>
            </a:extLst>
          </p:cNvPr>
          <p:cNvCxnSpPr>
            <a:cxnSpLocks/>
          </p:cNvCxnSpPr>
          <p:nvPr/>
        </p:nvCxnSpPr>
        <p:spPr>
          <a:xfrm flipV="1">
            <a:off x="1379482" y="5550453"/>
            <a:ext cx="0" cy="442843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AEC1BF71-F8A1-C44A-A5CB-B0F2D39840B2}"/>
              </a:ext>
            </a:extLst>
          </p:cNvPr>
          <p:cNvCxnSpPr>
            <a:cxnSpLocks/>
          </p:cNvCxnSpPr>
          <p:nvPr/>
        </p:nvCxnSpPr>
        <p:spPr>
          <a:xfrm flipV="1">
            <a:off x="2025526" y="5550453"/>
            <a:ext cx="0" cy="442843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6C848D13-C4DE-6740-AE5C-E180C63EE75D}"/>
              </a:ext>
            </a:extLst>
          </p:cNvPr>
          <p:cNvCxnSpPr>
            <a:cxnSpLocks/>
          </p:cNvCxnSpPr>
          <p:nvPr/>
        </p:nvCxnSpPr>
        <p:spPr>
          <a:xfrm flipV="1">
            <a:off x="6537891" y="5550453"/>
            <a:ext cx="0" cy="442843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0123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90</Words>
  <Application>Microsoft Office PowerPoint</Application>
  <PresentationFormat>画面に合わせる (4:3)</PresentationFormat>
  <Paragraphs>2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ＭＳ ゴシック</vt:lpstr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浩司</dc:creator>
  <cp:lastModifiedBy>tetsuya.hori.1970@gmail.com</cp:lastModifiedBy>
  <cp:revision>5</cp:revision>
  <cp:lastPrinted>2021-09-07T09:28:20Z</cp:lastPrinted>
  <dcterms:created xsi:type="dcterms:W3CDTF">2021-09-07T09:21:42Z</dcterms:created>
  <dcterms:modified xsi:type="dcterms:W3CDTF">2022-04-05T07:24:32Z</dcterms:modified>
</cp:coreProperties>
</file>